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11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ri.kassardjian\Desktop\facs%2011-21-1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E$15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D$22:$G$22</c:f>
                <c:numCache>
                  <c:formatCode>General</c:formatCode>
                  <c:ptCount val="4"/>
                  <c:pt idx="0">
                    <c:v>1.2710450643291782</c:v>
                  </c:pt>
                  <c:pt idx="1">
                    <c:v>0.85764535535123809</c:v>
                  </c:pt>
                  <c:pt idx="2">
                    <c:v>0.49888765156985965</c:v>
                  </c:pt>
                  <c:pt idx="3">
                    <c:v>0.70395706939809122</c:v>
                  </c:pt>
                </c:numCache>
              </c:numRef>
            </c:plus>
            <c:minus>
              <c:numRef>
                <c:f>Sheet1!$D$22:$G$22</c:f>
                <c:numCache>
                  <c:formatCode>General</c:formatCode>
                  <c:ptCount val="4"/>
                  <c:pt idx="0">
                    <c:v>1.2710450643291782</c:v>
                  </c:pt>
                  <c:pt idx="1">
                    <c:v>0.85764535535123809</c:v>
                  </c:pt>
                  <c:pt idx="2">
                    <c:v>0.49888765156985965</c:v>
                  </c:pt>
                  <c:pt idx="3">
                    <c:v>0.70395706939809122</c:v>
                  </c:pt>
                </c:numCache>
              </c:numRef>
            </c:minus>
          </c:errBars>
          <c:cat>
            <c:strRef>
              <c:f>Sheet1!$D$16:$D$19</c:f>
              <c:strCache>
                <c:ptCount val="4"/>
                <c:pt idx="0">
                  <c:v>Flag </c:v>
                </c:pt>
                <c:pt idx="1">
                  <c:v>Flag YY1 wt</c:v>
                </c:pt>
                <c:pt idx="2">
                  <c:v>Flag-YY1 S180,184A</c:v>
                </c:pt>
                <c:pt idx="3">
                  <c:v>Flag-YY1 S180,184D</c:v>
                </c:pt>
              </c:strCache>
            </c:strRef>
          </c:cat>
          <c:val>
            <c:numRef>
              <c:f>Sheet1!$E$16:$E$19</c:f>
              <c:numCache>
                <c:formatCode>0.00</c:formatCode>
                <c:ptCount val="4"/>
                <c:pt idx="0">
                  <c:v>66.766666666666666</c:v>
                </c:pt>
                <c:pt idx="1">
                  <c:v>71.766666666666666</c:v>
                </c:pt>
                <c:pt idx="2">
                  <c:v>72.466666666666654</c:v>
                </c:pt>
                <c:pt idx="3">
                  <c:v>71.166666666666671</c:v>
                </c:pt>
              </c:numCache>
            </c:numRef>
          </c:val>
        </c:ser>
        <c:ser>
          <c:idx val="1"/>
          <c:order val="1"/>
          <c:tx>
            <c:strRef>
              <c:f>Sheet1!$F$15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D$23:$G$23</c:f>
                <c:numCache>
                  <c:formatCode>General</c:formatCode>
                  <c:ptCount val="4"/>
                  <c:pt idx="0">
                    <c:v>0.28674417556808873</c:v>
                  </c:pt>
                  <c:pt idx="1">
                    <c:v>0.44969125210773475</c:v>
                  </c:pt>
                  <c:pt idx="2">
                    <c:v>0.32659863237109071</c:v>
                  </c:pt>
                  <c:pt idx="3">
                    <c:v>0.35590260840104326</c:v>
                  </c:pt>
                </c:numCache>
              </c:numRef>
            </c:plus>
            <c:minus>
              <c:numRef>
                <c:f>Sheet1!$D$23:$G$23</c:f>
                <c:numCache>
                  <c:formatCode>General</c:formatCode>
                  <c:ptCount val="4"/>
                  <c:pt idx="0">
                    <c:v>0.28674417556808873</c:v>
                  </c:pt>
                  <c:pt idx="1">
                    <c:v>0.44969125210773475</c:v>
                  </c:pt>
                  <c:pt idx="2">
                    <c:v>0.32659863237109071</c:v>
                  </c:pt>
                  <c:pt idx="3">
                    <c:v>0.35590260840104326</c:v>
                  </c:pt>
                </c:numCache>
              </c:numRef>
            </c:minus>
          </c:errBars>
          <c:cat>
            <c:strRef>
              <c:f>Sheet1!$D$16:$D$19</c:f>
              <c:strCache>
                <c:ptCount val="4"/>
                <c:pt idx="0">
                  <c:v>Flag </c:v>
                </c:pt>
                <c:pt idx="1">
                  <c:v>Flag YY1 wt</c:v>
                </c:pt>
                <c:pt idx="2">
                  <c:v>Flag-YY1 S180,184A</c:v>
                </c:pt>
                <c:pt idx="3">
                  <c:v>Flag-YY1 S180,184D</c:v>
                </c:pt>
              </c:strCache>
            </c:strRef>
          </c:cat>
          <c:val>
            <c:numRef>
              <c:f>Sheet1!$F$16:$F$19</c:f>
              <c:numCache>
                <c:formatCode>0.00</c:formatCode>
                <c:ptCount val="4"/>
                <c:pt idx="0">
                  <c:v>18.266666666666666</c:v>
                </c:pt>
                <c:pt idx="1">
                  <c:v>15.166666666666666</c:v>
                </c:pt>
                <c:pt idx="2">
                  <c:v>14.9</c:v>
                </c:pt>
                <c:pt idx="3">
                  <c:v>15.200000000000001</c:v>
                </c:pt>
              </c:numCache>
            </c:numRef>
          </c:val>
        </c:ser>
        <c:ser>
          <c:idx val="2"/>
          <c:order val="2"/>
          <c:tx>
            <c:strRef>
              <c:f>Sheet1!$G$15</c:f>
              <c:strCache>
                <c:ptCount val="1"/>
                <c:pt idx="0">
                  <c:v>G2/M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D$24:$G$24</c:f>
                <c:numCache>
                  <c:formatCode>General</c:formatCode>
                  <c:ptCount val="4"/>
                  <c:pt idx="0">
                    <c:v>0.85244745683629508</c:v>
                  </c:pt>
                  <c:pt idx="1">
                    <c:v>0.30912061651652317</c:v>
                  </c:pt>
                  <c:pt idx="2">
                    <c:v>0.18856180831641287</c:v>
                  </c:pt>
                  <c:pt idx="3">
                    <c:v>0.67986926847903806</c:v>
                  </c:pt>
                </c:numCache>
              </c:numRef>
            </c:plus>
            <c:minus>
              <c:numRef>
                <c:f>Sheet1!$D$24:$G$24</c:f>
                <c:numCache>
                  <c:formatCode>General</c:formatCode>
                  <c:ptCount val="4"/>
                  <c:pt idx="0">
                    <c:v>0.85244745683629508</c:v>
                  </c:pt>
                  <c:pt idx="1">
                    <c:v>0.30912061651652317</c:v>
                  </c:pt>
                  <c:pt idx="2">
                    <c:v>0.18856180831641287</c:v>
                  </c:pt>
                  <c:pt idx="3">
                    <c:v>0.67986926847903806</c:v>
                  </c:pt>
                </c:numCache>
              </c:numRef>
            </c:minus>
          </c:errBars>
          <c:cat>
            <c:strRef>
              <c:f>Sheet1!$D$16:$D$19</c:f>
              <c:strCache>
                <c:ptCount val="4"/>
                <c:pt idx="0">
                  <c:v>Flag </c:v>
                </c:pt>
                <c:pt idx="1">
                  <c:v>Flag YY1 wt</c:v>
                </c:pt>
                <c:pt idx="2">
                  <c:v>Flag-YY1 S180,184A</c:v>
                </c:pt>
                <c:pt idx="3">
                  <c:v>Flag-YY1 S180,184D</c:v>
                </c:pt>
              </c:strCache>
            </c:strRef>
          </c:cat>
          <c:val>
            <c:numRef>
              <c:f>Sheet1!$G$16:$G$19</c:f>
              <c:numCache>
                <c:formatCode>0.00</c:formatCode>
                <c:ptCount val="4"/>
                <c:pt idx="0">
                  <c:v>13.399999999999999</c:v>
                </c:pt>
                <c:pt idx="1">
                  <c:v>11.833333333333334</c:v>
                </c:pt>
                <c:pt idx="2">
                  <c:v>11.333333333333334</c:v>
                </c:pt>
                <c:pt idx="3">
                  <c:v>12.4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7726080"/>
        <c:axId val="57727616"/>
      </c:barChart>
      <c:catAx>
        <c:axId val="57726080"/>
        <c:scaling>
          <c:orientation val="minMax"/>
        </c:scaling>
        <c:delete val="0"/>
        <c:axPos val="b"/>
        <c:majorTickMark val="out"/>
        <c:minorTickMark val="none"/>
        <c:tickLblPos val="nextTo"/>
        <c:crossAx val="57727616"/>
        <c:crosses val="autoZero"/>
        <c:auto val="1"/>
        <c:lblAlgn val="ctr"/>
        <c:lblOffset val="100"/>
        <c:noMultiLvlLbl val="0"/>
      </c:catAx>
      <c:valAx>
        <c:axId val="57727616"/>
        <c:scaling>
          <c:orientation val="minMax"/>
        </c:scaling>
        <c:delete val="0"/>
        <c:axPos val="l"/>
        <c:majorGridlines/>
        <c:numFmt formatCode="0.00" sourceLinked="1"/>
        <c:majorTickMark val="out"/>
        <c:minorTickMark val="none"/>
        <c:tickLblPos val="nextTo"/>
        <c:crossAx val="5772608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357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083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895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13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825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310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238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498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531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01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1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4BEDFF-511C-4C58-9AF9-2304232017F6}" type="datetimeFigureOut">
              <a:rPr lang="en-US" smtClean="0"/>
              <a:t>10/2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1DF49E-32F0-4EDF-B54B-E4227A1FD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635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7658082"/>
              </p:ext>
            </p:extLst>
          </p:nvPr>
        </p:nvGraphicFramePr>
        <p:xfrm>
          <a:off x="2130321" y="614297"/>
          <a:ext cx="5337280" cy="27385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 rot="16200000">
            <a:off x="1315529" y="1804601"/>
            <a:ext cx="1447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Cell number (%)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52400" y="152400"/>
            <a:ext cx="891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578785" y="457200"/>
            <a:ext cx="2393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u="sng" dirty="0" smtClean="0">
                <a:latin typeface="Arial" pitchFamily="34" charset="0"/>
                <a:cs typeface="Arial" pitchFamily="34" charset="0"/>
              </a:rPr>
              <a:t>Cell Cycle Progression</a:t>
            </a:r>
            <a:endParaRPr lang="en-US" sz="1200" b="1" u="sng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2" descr="C:\Users\ari.kassardjian\Desktop\2-15-12 HEK Flag-YY1 CONFOCAL\2-15-12 HEK Flag-YY1_WT63XDAPI_ch00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0" y="3754436"/>
            <a:ext cx="1050794" cy="9699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3" descr="C:\Users\ari.kassardjian\Desktop\2-15-12 HEK Flag-YY1 CONFOCAL\2-15-12 HEK Flag-YY1_WT63XFlag_ch0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4587" y="3754436"/>
            <a:ext cx="1050794" cy="9699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4" descr="C:\Users\ari.kassardjian\Desktop\2-15-12 HEK Flag-YY1 CONFOCAL\2-15-12 HEK Flag-YY1_WT63XOL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599" y="3754436"/>
            <a:ext cx="1050794" cy="9699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5" descr="C:\Users\ari.kassardjian\Desktop\2-15-12 HEK Flag-YY1 CONFOCAL\2-15-12 HEK Flag-YY1_RD2A63XOL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599" y="4811754"/>
            <a:ext cx="1050794" cy="9032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6" descr="C:\Users\ari.kassardjian\Desktop\2-15-12 HEK Flag-YY1 CONFOCAL\2-15-12 HEK Flag-YY1_RD2A63XDAPI_ch00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0" y="4811754"/>
            <a:ext cx="1050794" cy="9032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7" descr="C:\Users\ari.kassardjian\Desktop\2-15-12 HEK Flag-YY1 CONFOCAL\2-15-12 HEK Flag-YY1_RD2A63XFlag_ch00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4587" y="4800868"/>
            <a:ext cx="1050794" cy="9032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" descr="C:\Users\ari.kassardjian\Desktop\2-15-12 HEK Flag-YY1 CONFOCAL\2-15-12 HEK Flag-YY1_RD2D63XOL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5770121"/>
            <a:ext cx="1066800" cy="9354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3" descr="C:\Users\ari.kassardjian\Desktop\2-15-12 HEK Flag-YY1 CONFOCAL\2-15-12 HEK Flag-YY1_RD2D63XDAPI_ch00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1" y="5741921"/>
            <a:ext cx="1066800" cy="9354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" descr="C:\Users\ari.kassardjian\Desktop\2-15-12 HEK Flag-YY1 CONFOCAL\2-15-12 HEK Flag-YY1_RD2D63XFlag_ch00.tif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3200" y="5741921"/>
            <a:ext cx="1066800" cy="9354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1614101" y="4239418"/>
            <a:ext cx="12052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Flag-YY1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wt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097347" y="5252491"/>
            <a:ext cx="16458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Flag-YY1 S180,184A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097347" y="6099360"/>
            <a:ext cx="1722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Flag-YY1S180,184D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63289" y="244733"/>
            <a:ext cx="879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33400" y="3456801"/>
            <a:ext cx="879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717493" y="3456801"/>
            <a:ext cx="746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   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Flag                     DAPI                   MERGE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3542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ollege of Medicine, Florida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</cp:revision>
  <dcterms:created xsi:type="dcterms:W3CDTF">2012-10-29T13:18:19Z</dcterms:created>
  <dcterms:modified xsi:type="dcterms:W3CDTF">2012-10-29T13:18:45Z</dcterms:modified>
</cp:coreProperties>
</file>